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6408738"/>
  <p:notesSz cx="6624638" cy="98488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A06C53-39D4-44CB-B4BF-53A1BCFC25F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257040"/>
            <a:ext cx="6172200" cy="106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1495080"/>
            <a:ext cx="6172200" cy="201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3704040"/>
            <a:ext cx="6172200" cy="201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D30A8B-193C-4691-978F-1779882A191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257040"/>
            <a:ext cx="6172200" cy="106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1495080"/>
            <a:ext cx="3011760" cy="201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1495080"/>
            <a:ext cx="3011760" cy="201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3704040"/>
            <a:ext cx="3011760" cy="201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3704040"/>
            <a:ext cx="3011760" cy="201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063F1C-8862-444E-A4F8-65E31BFE2D6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257040"/>
            <a:ext cx="6172200" cy="106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1495080"/>
            <a:ext cx="1987200" cy="201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1495080"/>
            <a:ext cx="1987200" cy="201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1495080"/>
            <a:ext cx="1987200" cy="201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3704040"/>
            <a:ext cx="1987200" cy="201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3704040"/>
            <a:ext cx="1987200" cy="201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3704040"/>
            <a:ext cx="1987200" cy="201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16AA7E-6DAC-4DA8-92F8-231E6B172C8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257040"/>
            <a:ext cx="6172200" cy="106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1495080"/>
            <a:ext cx="6172200" cy="4228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BC0471-AC98-496B-86DE-014B2F36BEA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257040"/>
            <a:ext cx="6172200" cy="106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1495080"/>
            <a:ext cx="6172200" cy="422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BF96B3-FDD0-4009-81FB-5B9FDE58E5A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257040"/>
            <a:ext cx="6172200" cy="106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1495080"/>
            <a:ext cx="3011760" cy="422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1495080"/>
            <a:ext cx="3011760" cy="422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2CFEC3-38BE-4A98-8AC3-B78522A0E39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257040"/>
            <a:ext cx="6172200" cy="106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FF4FC1-82CC-4EFF-B838-7403F7E9728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257040"/>
            <a:ext cx="6172200" cy="4954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A347BE-000C-4629-9079-366CCE87F7F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257040"/>
            <a:ext cx="6172200" cy="106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1495080"/>
            <a:ext cx="3011760" cy="201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1495080"/>
            <a:ext cx="3011760" cy="422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3704040"/>
            <a:ext cx="3011760" cy="201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D0DA0C-8196-4FD1-8FC7-651F2E7D42B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257040"/>
            <a:ext cx="6172200" cy="106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1495080"/>
            <a:ext cx="3011760" cy="422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1495080"/>
            <a:ext cx="3011760" cy="201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3704040"/>
            <a:ext cx="3011760" cy="201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0F0873-E11D-4B4D-9CF0-C5B6ECFE5C8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257040"/>
            <a:ext cx="6172200" cy="106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1495080"/>
            <a:ext cx="3011760" cy="201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1495080"/>
            <a:ext cx="3011760" cy="201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3704040"/>
            <a:ext cx="6172200" cy="2017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C4B005-BB23-47A1-BAF3-4C2432F238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257040"/>
            <a:ext cx="6172200" cy="10684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1495080"/>
            <a:ext cx="6172200" cy="422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2000"/>
          </a:bodyPr>
          <a:p>
            <a:pPr marL="315360" indent="-31536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683280" indent="-2628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051560" indent="-21024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472040" indent="-2102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1892520" indent="-21024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1892520" indent="-21024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1892520" indent="-21024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5835240"/>
            <a:ext cx="1600200" cy="444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5835240"/>
            <a:ext cx="2171520" cy="444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5835240"/>
            <a:ext cx="1600200" cy="444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E3671DC-BD72-4DD8-AB90-161CB9E72E84}" type="slidenum">
              <a:rPr b="0" lang="it-I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3.png"/><Relationship Id="rId5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314280" y="-144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189000" y="1440000"/>
            <a:ext cx="6480000" cy="2592360"/>
            <a:chOff x="189000" y="1440000"/>
            <a:chExt cx="6480000" cy="2592360"/>
          </a:xfrm>
        </p:grpSpPr>
        <p:pic>
          <p:nvPicPr>
            <p:cNvPr id="43" name="" descr=""/>
            <p:cNvPicPr/>
            <p:nvPr/>
          </p:nvPicPr>
          <p:blipFill>
            <a:blip r:embed="rId1"/>
            <a:srcRect l="0" t="23468" r="3454" b="0"/>
            <a:stretch/>
          </p:blipFill>
          <p:spPr>
            <a:xfrm>
              <a:off x="189000" y="1440000"/>
              <a:ext cx="6480000" cy="2592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"/>
            <p:cNvSpPr/>
            <p:nvPr/>
          </p:nvSpPr>
          <p:spPr>
            <a:xfrm>
              <a:off x="2642400" y="2913120"/>
              <a:ext cx="361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1" lang="en-US" sz="1000" spc="-1" strike="noStrike" baseline="30000">
                  <a:solidFill>
                    <a:srgbClr val="000000"/>
                  </a:solidFill>
                  <a:latin typeface="Arial"/>
                </a:rPr>
                <a:t>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3216960" y="2913120"/>
              <a:ext cx="361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1" lang="en-US" sz="1000" spc="-1" strike="noStrike" baseline="30000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3866400" y="2913120"/>
              <a:ext cx="361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1" lang="en-US" sz="1000" spc="-1" strike="noStrike" baseline="30000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4485600" y="2913120"/>
              <a:ext cx="361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1" lang="en-US" sz="1000" spc="-1" strike="noStrike" baseline="30000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5090400" y="2913120"/>
              <a:ext cx="361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1" lang="en-US" sz="1000" spc="-1" strike="noStrike" baseline="30000">
                  <a:solidFill>
                    <a:srgbClr val="000000"/>
                  </a:solidFill>
                  <a:latin typeface="Arial"/>
                </a:rPr>
                <a:t>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5666400" y="2913120"/>
              <a:ext cx="361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1" lang="en-US" sz="1000" spc="-1" strike="noStrike" baseline="30000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0" name=""/>
          <p:cNvGrpSpPr/>
          <p:nvPr/>
        </p:nvGrpSpPr>
        <p:grpSpPr>
          <a:xfrm>
            <a:off x="333360" y="4103640"/>
            <a:ext cx="5540760" cy="2125800"/>
            <a:chOff x="333360" y="4103640"/>
            <a:chExt cx="5540760" cy="2125800"/>
          </a:xfrm>
        </p:grpSpPr>
        <p:sp>
          <p:nvSpPr>
            <p:cNvPr id="51" name=""/>
            <p:cNvSpPr/>
            <p:nvPr/>
          </p:nvSpPr>
          <p:spPr>
            <a:xfrm>
              <a:off x="335160" y="4103640"/>
              <a:ext cx="349920" cy="398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</a:rPr>
                <a:t>B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2" name="" descr=""/>
            <p:cNvPicPr/>
            <p:nvPr/>
          </p:nvPicPr>
          <p:blipFill>
            <a:blip r:embed="rId2"/>
            <a:srcRect l="0" t="5432" r="5375" b="0"/>
            <a:stretch/>
          </p:blipFill>
          <p:spPr>
            <a:xfrm>
              <a:off x="333360" y="4724280"/>
              <a:ext cx="5256360" cy="1505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3" name=""/>
            <p:cNvSpPr/>
            <p:nvPr/>
          </p:nvSpPr>
          <p:spPr>
            <a:xfrm>
              <a:off x="2852640" y="4357800"/>
              <a:ext cx="0" cy="1665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3573360" y="4933800"/>
              <a:ext cx="0" cy="1068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2788200" y="4357800"/>
              <a:ext cx="5115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</a:rPr>
                <a:t>73.5°C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3493080" y="4933800"/>
              <a:ext cx="5115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</a:rPr>
                <a:t>75.5°C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2493720" y="4873680"/>
              <a:ext cx="6256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900" spc="-1" strike="noStrike">
                  <a:solidFill>
                    <a:srgbClr val="000000"/>
                  </a:solidFill>
                  <a:latin typeface="Times New Roman"/>
                </a:rPr>
                <a:t>159 bp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900" spc="-1" strike="noStrike">
                  <a:solidFill>
                    <a:srgbClr val="000000"/>
                  </a:solidFill>
                  <a:latin typeface="Times New Roman"/>
                </a:rPr>
                <a:t>integrase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3316320" y="5408640"/>
              <a:ext cx="5115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900" spc="-1" strike="noStrike">
                  <a:solidFill>
                    <a:srgbClr val="000000"/>
                  </a:solidFill>
                  <a:latin typeface="Times New Roman"/>
                </a:rPr>
                <a:t>173 bp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900" spc="-1" strike="noStrike">
                  <a:solidFill>
                    <a:srgbClr val="000000"/>
                  </a:solidFill>
                  <a:latin typeface="Times New Roman"/>
                </a:rPr>
                <a:t>circle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9" name=""/>
            <p:cNvGrpSpPr/>
            <p:nvPr/>
          </p:nvGrpSpPr>
          <p:grpSpPr>
            <a:xfrm>
              <a:off x="4504320" y="4374720"/>
              <a:ext cx="1369800" cy="1330200"/>
              <a:chOff x="4504320" y="4374720"/>
              <a:chExt cx="1369800" cy="1330200"/>
            </a:xfrm>
          </p:grpSpPr>
          <p:grpSp>
            <p:nvGrpSpPr>
              <p:cNvPr id="60" name=""/>
              <p:cNvGrpSpPr/>
              <p:nvPr/>
            </p:nvGrpSpPr>
            <p:grpSpPr>
              <a:xfrm>
                <a:off x="4504320" y="4374720"/>
                <a:ext cx="1369800" cy="1211040"/>
                <a:chOff x="4504320" y="4374720"/>
                <a:chExt cx="1369800" cy="1211040"/>
              </a:xfrm>
            </p:grpSpPr>
            <p:grpSp>
              <p:nvGrpSpPr>
                <p:cNvPr id="61" name=""/>
                <p:cNvGrpSpPr/>
                <p:nvPr/>
              </p:nvGrpSpPr>
              <p:grpSpPr>
                <a:xfrm>
                  <a:off x="4882680" y="4924080"/>
                  <a:ext cx="649440" cy="661680"/>
                  <a:chOff x="4882680" y="4924080"/>
                  <a:chExt cx="649440" cy="661680"/>
                </a:xfrm>
              </p:grpSpPr>
              <p:pic>
                <p:nvPicPr>
                  <p:cNvPr id="62" name="" descr=""/>
                  <p:cNvPicPr/>
                  <p:nvPr/>
                </p:nvPicPr>
                <p:blipFill>
                  <a:blip r:embed="rId3">
                    <a:lum bright="6000"/>
                  </a:blip>
                  <a:srcRect l="8450" t="39566" r="14989" b="0"/>
                  <a:stretch/>
                </p:blipFill>
                <p:spPr>
                  <a:xfrm>
                    <a:off x="4882680" y="4924080"/>
                    <a:ext cx="649440" cy="6616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pic>
                <p:nvPicPr>
                  <p:cNvPr id="63" name="" descr=""/>
                  <p:cNvPicPr/>
                  <p:nvPr/>
                </p:nvPicPr>
                <p:blipFill>
                  <a:blip r:embed="rId4">
                    <a:lum bright="6000"/>
                  </a:blip>
                  <a:srcRect l="0" t="24647" r="74565" b="16234"/>
                  <a:stretch/>
                </p:blipFill>
                <p:spPr>
                  <a:xfrm>
                    <a:off x="4882680" y="4924080"/>
                    <a:ext cx="216000" cy="6472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grpSp>
            <p:sp>
              <p:nvSpPr>
                <p:cNvPr id="64" name=""/>
                <p:cNvSpPr/>
                <p:nvPr/>
              </p:nvSpPr>
              <p:spPr>
                <a:xfrm>
                  <a:off x="5555520" y="4733640"/>
                  <a:ext cx="30564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it-IT" sz="800" spc="-1" strike="noStrike">
                      <a:solidFill>
                        <a:srgbClr val="000000"/>
                      </a:solidFill>
                      <a:latin typeface="Arial"/>
                    </a:rPr>
                    <a:t>bp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" name=""/>
                <p:cNvSpPr/>
                <p:nvPr/>
              </p:nvSpPr>
              <p:spPr>
                <a:xfrm rot="2785200">
                  <a:off x="4480560" y="4588920"/>
                  <a:ext cx="69120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it-IT" sz="900" spc="-1" strike="noStrike">
                      <a:solidFill>
                        <a:srgbClr val="000000"/>
                      </a:solidFill>
                      <a:latin typeface="Arial"/>
                    </a:rPr>
                    <a:t>integrase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" name=""/>
                <p:cNvSpPr/>
                <p:nvPr/>
              </p:nvSpPr>
              <p:spPr>
                <a:xfrm rot="2785200">
                  <a:off x="4824720" y="4649040"/>
                  <a:ext cx="48096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it-IT" sz="900" spc="-1" strike="noStrike">
                      <a:solidFill>
                        <a:srgbClr val="000000"/>
                      </a:solidFill>
                      <a:latin typeface="Arial"/>
                    </a:rPr>
                    <a:t>circle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" name=""/>
                <p:cNvSpPr/>
                <p:nvPr/>
              </p:nvSpPr>
              <p:spPr>
                <a:xfrm rot="2785200">
                  <a:off x="5056920" y="4641120"/>
                  <a:ext cx="563400" cy="2311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900" spc="-1" strike="noStrike">
                      <a:solidFill>
                        <a:srgbClr val="000000"/>
                      </a:solidFill>
                      <a:latin typeface="Arial"/>
                    </a:rPr>
                    <a:t>marker</a:t>
                  </a:r>
                  <a:endParaRPr b="0" lang="en-US" sz="9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" name=""/>
                <p:cNvSpPr/>
                <p:nvPr/>
              </p:nvSpPr>
              <p:spPr>
                <a:xfrm>
                  <a:off x="5542560" y="4873320"/>
                  <a:ext cx="326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</a:rPr>
                    <a:t>500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" name=""/>
                <p:cNvSpPr/>
                <p:nvPr/>
              </p:nvSpPr>
              <p:spPr>
                <a:xfrm>
                  <a:off x="5547240" y="4970160"/>
                  <a:ext cx="326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</a:rPr>
                    <a:t>400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" name=""/>
                <p:cNvSpPr/>
                <p:nvPr/>
              </p:nvSpPr>
              <p:spPr>
                <a:xfrm>
                  <a:off x="5542560" y="5065560"/>
                  <a:ext cx="326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</a:rPr>
                    <a:t>300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" name=""/>
                <p:cNvSpPr/>
                <p:nvPr/>
              </p:nvSpPr>
              <p:spPr>
                <a:xfrm>
                  <a:off x="5542560" y="5173560"/>
                  <a:ext cx="326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</a:rPr>
                    <a:t>200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" name=""/>
                <p:cNvSpPr/>
                <p:nvPr/>
              </p:nvSpPr>
              <p:spPr>
                <a:xfrm>
                  <a:off x="5537520" y="5303520"/>
                  <a:ext cx="326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</a:rPr>
                    <a:t>100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" name=""/>
                <p:cNvSpPr/>
                <p:nvPr/>
              </p:nvSpPr>
              <p:spPr>
                <a:xfrm>
                  <a:off x="5532120" y="5009760"/>
                  <a:ext cx="712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" name=""/>
                <p:cNvSpPr/>
                <p:nvPr/>
              </p:nvSpPr>
              <p:spPr>
                <a:xfrm>
                  <a:off x="5532120" y="5403600"/>
                  <a:ext cx="712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" name=""/>
                <p:cNvSpPr/>
                <p:nvPr/>
              </p:nvSpPr>
              <p:spPr>
                <a:xfrm>
                  <a:off x="5532120" y="5067000"/>
                  <a:ext cx="712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" name=""/>
                <p:cNvSpPr/>
                <p:nvPr/>
              </p:nvSpPr>
              <p:spPr>
                <a:xfrm>
                  <a:off x="5532120" y="5144760"/>
                  <a:ext cx="712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" name=""/>
                <p:cNvSpPr/>
                <p:nvPr/>
              </p:nvSpPr>
              <p:spPr>
                <a:xfrm>
                  <a:off x="5532120" y="5263920"/>
                  <a:ext cx="712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78" name=""/>
              <p:cNvSpPr/>
              <p:nvPr/>
            </p:nvSpPr>
            <p:spPr>
              <a:xfrm>
                <a:off x="4568760" y="4410000"/>
                <a:ext cx="1295640" cy="1294920"/>
              </a:xfrm>
              <a:prstGeom prst="rect">
                <a:avLst/>
              </a:prstGeom>
              <a:noFill/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79" name=""/>
          <p:cNvGrpSpPr/>
          <p:nvPr/>
        </p:nvGrpSpPr>
        <p:grpSpPr>
          <a:xfrm>
            <a:off x="623520" y="-36360"/>
            <a:ext cx="3424680" cy="1839240"/>
            <a:chOff x="623520" y="-36360"/>
            <a:chExt cx="3424680" cy="1839240"/>
          </a:xfrm>
        </p:grpSpPr>
        <p:sp>
          <p:nvSpPr>
            <p:cNvPr id="80" name=""/>
            <p:cNvSpPr/>
            <p:nvPr/>
          </p:nvSpPr>
          <p:spPr>
            <a:xfrm>
              <a:off x="3359160" y="1560600"/>
              <a:ext cx="431640" cy="228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,7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2576520" y="1560600"/>
              <a:ext cx="782640" cy="228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9.33/0.80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1928880" y="1560600"/>
              <a:ext cx="473040" cy="228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1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1128600" y="1560600"/>
              <a:ext cx="800280" cy="228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9.85/0.03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674640" y="1560600"/>
              <a:ext cx="453960" cy="228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</a:t>
              </a:r>
              <a:r>
                <a:rPr b="1" lang="en-GB" sz="9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3359160" y="1332000"/>
              <a:ext cx="431640" cy="228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3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2576520" y="1332000"/>
              <a:ext cx="782640" cy="228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6.12/0.10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1928880" y="1332000"/>
              <a:ext cx="473040" cy="228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1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1128600" y="1332000"/>
              <a:ext cx="800280" cy="228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6.00/0.04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674640" y="1332000"/>
              <a:ext cx="453960" cy="228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</a:t>
              </a:r>
              <a:r>
                <a:rPr b="1" lang="en-GB" sz="9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3359160" y="1103400"/>
              <a:ext cx="431640" cy="228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.5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2576520" y="1103400"/>
              <a:ext cx="782640" cy="228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2.36/0.35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1928880" y="1103400"/>
              <a:ext cx="473040" cy="228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3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1128600" y="1103400"/>
              <a:ext cx="800280" cy="228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2.40/0.07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674640" y="1103400"/>
              <a:ext cx="453960" cy="228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</a:t>
              </a:r>
              <a:r>
                <a:rPr b="1" lang="en-GB" sz="9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3359160" y="874800"/>
              <a:ext cx="431640" cy="228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9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2576520" y="874800"/>
              <a:ext cx="782640" cy="228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8.63/0.17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1928880" y="874800"/>
              <a:ext cx="473040" cy="228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6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1128600" y="874800"/>
              <a:ext cx="800280" cy="228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8.61/0.11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674640" y="874800"/>
              <a:ext cx="453960" cy="228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</a:t>
              </a:r>
              <a:r>
                <a:rPr b="1" lang="en-GB" sz="9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3359160" y="646200"/>
              <a:ext cx="431640" cy="228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.3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2576520" y="646200"/>
              <a:ext cx="782640" cy="228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4.78/0.34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1928880" y="646200"/>
              <a:ext cx="473040" cy="228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.3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1128600" y="646200"/>
              <a:ext cx="800280" cy="228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4.78/0.05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674640" y="646200"/>
              <a:ext cx="453960" cy="228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</a:t>
              </a:r>
              <a:r>
                <a:rPr b="1" lang="en-GB" sz="9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3359160" y="417600"/>
              <a:ext cx="431640" cy="228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3.9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2576520" y="417600"/>
              <a:ext cx="782640" cy="228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1.14/0.43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1928880" y="417600"/>
              <a:ext cx="473040" cy="228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.1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1128600" y="417600"/>
              <a:ext cx="800280" cy="228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1.09/0.12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674640" y="417600"/>
              <a:ext cx="453960" cy="228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</a:t>
              </a:r>
              <a:r>
                <a:rPr b="1" lang="en-GB" sz="9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 flipV="1">
              <a:off x="674640" y="404640"/>
              <a:ext cx="3270240" cy="17280"/>
            </a:xfrm>
            <a:prstGeom prst="line">
              <a:avLst/>
            </a:prstGeom>
            <a:ln cap="rnd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 flipV="1">
              <a:off x="674640" y="1782720"/>
              <a:ext cx="3270240" cy="20160"/>
            </a:xfrm>
            <a:prstGeom prst="line">
              <a:avLst/>
            </a:prstGeom>
            <a:ln cap="rnd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640" bIns="-26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674640" y="417600"/>
              <a:ext cx="0" cy="1371240"/>
            </a:xfrm>
            <a:prstGeom prst="line">
              <a:avLst/>
            </a:prstGeom>
            <a:ln cap="rnd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3944880" y="417600"/>
              <a:ext cx="0" cy="1371240"/>
            </a:xfrm>
            <a:prstGeom prst="line">
              <a:avLst/>
            </a:prstGeom>
            <a:ln cap="rnd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674640" y="646200"/>
              <a:ext cx="1727280" cy="0"/>
            </a:xfrm>
            <a:prstGeom prst="line">
              <a:avLst/>
            </a:prstGeom>
            <a:ln cap="rnd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1128600" y="417600"/>
              <a:ext cx="0" cy="1371240"/>
            </a:xfrm>
            <a:prstGeom prst="line">
              <a:avLst/>
            </a:prstGeom>
            <a:ln cap="rnd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1928880" y="417600"/>
              <a:ext cx="0" cy="1371240"/>
            </a:xfrm>
            <a:prstGeom prst="line">
              <a:avLst/>
            </a:prstGeom>
            <a:ln cap="rnd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2401920" y="417600"/>
              <a:ext cx="0" cy="1371240"/>
            </a:xfrm>
            <a:prstGeom prst="line">
              <a:avLst/>
            </a:prstGeom>
            <a:ln cap="rnd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2576520" y="417600"/>
              <a:ext cx="0" cy="1371240"/>
            </a:xfrm>
            <a:prstGeom prst="line">
              <a:avLst/>
            </a:prstGeom>
            <a:ln cap="rnd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2576520" y="646200"/>
              <a:ext cx="1214280" cy="0"/>
            </a:xfrm>
            <a:prstGeom prst="line">
              <a:avLst/>
            </a:prstGeom>
            <a:ln cap="rnd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3359160" y="417600"/>
              <a:ext cx="0" cy="1371240"/>
            </a:xfrm>
            <a:prstGeom prst="line">
              <a:avLst/>
            </a:prstGeom>
            <a:ln cap="rnd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3790800" y="417600"/>
              <a:ext cx="0" cy="1371240"/>
            </a:xfrm>
            <a:prstGeom prst="line">
              <a:avLst/>
            </a:prstGeom>
            <a:ln cap="rnd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674640" y="874800"/>
              <a:ext cx="1727280" cy="0"/>
            </a:xfrm>
            <a:prstGeom prst="line">
              <a:avLst/>
            </a:prstGeom>
            <a:ln cap="rnd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2576520" y="874800"/>
              <a:ext cx="1214280" cy="0"/>
            </a:xfrm>
            <a:prstGeom prst="line">
              <a:avLst/>
            </a:prstGeom>
            <a:ln cap="rnd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674640" y="1103400"/>
              <a:ext cx="1727280" cy="0"/>
            </a:xfrm>
            <a:prstGeom prst="line">
              <a:avLst/>
            </a:prstGeom>
            <a:ln cap="rnd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2576520" y="1103400"/>
              <a:ext cx="1214280" cy="0"/>
            </a:xfrm>
            <a:prstGeom prst="line">
              <a:avLst/>
            </a:prstGeom>
            <a:ln cap="rnd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674640" y="1332000"/>
              <a:ext cx="1727280" cy="0"/>
            </a:xfrm>
            <a:prstGeom prst="line">
              <a:avLst/>
            </a:prstGeom>
            <a:ln cap="rnd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2576520" y="1332000"/>
              <a:ext cx="1214280" cy="0"/>
            </a:xfrm>
            <a:prstGeom prst="line">
              <a:avLst/>
            </a:prstGeom>
            <a:ln cap="rnd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674640" y="1560600"/>
              <a:ext cx="1727280" cy="0"/>
            </a:xfrm>
            <a:prstGeom prst="line">
              <a:avLst/>
            </a:prstGeom>
            <a:ln cap="rnd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2576520" y="1560600"/>
              <a:ext cx="1214280" cy="0"/>
            </a:xfrm>
            <a:prstGeom prst="line">
              <a:avLst/>
            </a:prstGeom>
            <a:ln cap="rnd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623520" y="135000"/>
              <a:ext cx="5526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700" spc="-1" strike="noStrike">
                  <a:solidFill>
                    <a:srgbClr val="000000"/>
                  </a:solidFill>
                  <a:latin typeface="Arial"/>
                </a:rPr>
                <a:t>Copy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700" spc="-1" strike="noStrike">
                  <a:solidFill>
                    <a:srgbClr val="000000"/>
                  </a:solidFill>
                  <a:latin typeface="Arial"/>
                </a:rPr>
                <a:t>numbers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1209600" y="190440"/>
              <a:ext cx="673200" cy="21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700" spc="-1" strike="noStrike">
                  <a:solidFill>
                    <a:srgbClr val="000000"/>
                  </a:solidFill>
                  <a:latin typeface="Arial"/>
                </a:rPr>
                <a:t>Mean C</a:t>
              </a:r>
              <a:r>
                <a:rPr b="1" lang="en-GB" sz="700" spc="-1" strike="noStrike" baseline="-25000">
                  <a:solidFill>
                    <a:srgbClr val="000000"/>
                  </a:solidFill>
                  <a:latin typeface="Arial"/>
                </a:rPr>
                <a:t>T</a:t>
              </a:r>
              <a:r>
                <a:rPr b="1" lang="en-GB" sz="700" spc="-1" strike="noStrike">
                  <a:solidFill>
                    <a:srgbClr val="000000"/>
                  </a:solidFill>
                  <a:latin typeface="Arial"/>
                </a:rPr>
                <a:t>/SD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1934640" y="189000"/>
              <a:ext cx="4658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700" spc="-1" strike="noStrike">
                  <a:solidFill>
                    <a:srgbClr val="000000"/>
                  </a:solidFill>
                  <a:latin typeface="Arial"/>
                </a:rPr>
                <a:t>CV (%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2608200" y="185760"/>
              <a:ext cx="673200" cy="214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700" spc="-1" strike="noStrike">
                  <a:solidFill>
                    <a:srgbClr val="000000"/>
                  </a:solidFill>
                  <a:latin typeface="Arial"/>
                </a:rPr>
                <a:t>Mean C</a:t>
              </a:r>
              <a:r>
                <a:rPr b="1" lang="en-GB" sz="700" spc="-1" strike="noStrike" baseline="-25000">
                  <a:solidFill>
                    <a:srgbClr val="000000"/>
                  </a:solidFill>
                  <a:latin typeface="Arial"/>
                </a:rPr>
                <a:t>T</a:t>
              </a:r>
              <a:r>
                <a:rPr b="1" lang="en-GB" sz="700" spc="-1" strike="noStrike">
                  <a:solidFill>
                    <a:srgbClr val="000000"/>
                  </a:solidFill>
                  <a:latin typeface="Arial"/>
                </a:rPr>
                <a:t>/SD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3333240" y="183960"/>
              <a:ext cx="4658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700" spc="-1" strike="noStrike">
                  <a:solidFill>
                    <a:srgbClr val="000000"/>
                  </a:solidFill>
                  <a:latin typeface="Arial"/>
                </a:rPr>
                <a:t>CV (%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1033560" y="-36360"/>
              <a:ext cx="15462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Arial"/>
                </a:rPr>
                <a:t>Intra-assay variation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2502000" y="-28440"/>
              <a:ext cx="15462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100" spc="-1" strike="noStrike">
                  <a:solidFill>
                    <a:srgbClr val="000000"/>
                  </a:solidFill>
                  <a:latin typeface="Arial"/>
                </a:rPr>
                <a:t>Inter-assay variation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 rot="16200000">
              <a:off x="1956960" y="1019160"/>
              <a:ext cx="1007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700" spc="-1" strike="noStrike">
                  <a:solidFill>
                    <a:srgbClr val="000000"/>
                  </a:solidFill>
                  <a:latin typeface="Arial"/>
                </a:rPr>
                <a:t>Test efficiency 95%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1136520" y="222120"/>
              <a:ext cx="13687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 rot="16200000">
              <a:off x="3342960" y="1019160"/>
              <a:ext cx="100764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700" spc="-1" strike="noStrike">
                  <a:solidFill>
                    <a:srgbClr val="000000"/>
                  </a:solidFill>
                  <a:latin typeface="Arial"/>
                </a:rPr>
                <a:t>Test efficiency 90%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2576520" y="222120"/>
              <a:ext cx="13683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7-25T08:52:36Z</dcterms:created>
  <dc:creator>ciervo_alessandra</dc:creator>
  <dc:description/>
  <dc:language>en-US</dc:language>
  <cp:lastModifiedBy>ISS</cp:lastModifiedBy>
  <dcterms:modified xsi:type="dcterms:W3CDTF">2007-08-26T18:35:46Z</dcterms:modified>
  <cp:revision>15</cp:revision>
  <dc:subject/>
  <dc:title>Diapositiva 1</dc:title>
</cp:coreProperties>
</file>